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  <Override PartName="/ppt/charts/colors4.xml" ContentType="application/vnd.ms-office.chartcolorstyle+xml"/>
  <Override PartName="/ppt/charts/style4.xml" ContentType="application/vnd.ms-office.chartstyle+xml"/>
  <Override PartName="/ppt/charts/colors5.xml" ContentType="application/vnd.ms-office.chartcolorstyle+xml"/>
  <Override PartName="/ppt/charts/style5.xml" ContentType="application/vnd.ms-office.chartstyle+xml"/>
  <Override PartName="/ppt/charts/colors6.xml" ContentType="application/vnd.ms-office.chartcolorstyle+xml"/>
  <Override PartName="/ppt/charts/style6.xml" ContentType="application/vnd.ms-office.chartstyle+xml"/>
  <Override PartName="/ppt/charts/colors7.xml" ContentType="application/vnd.ms-office.chartcolorstyle+xml"/>
  <Override PartName="/ppt/charts/style7.xml" ContentType="application/vnd.ms-office.chartstyle+xml"/>
  <Override PartName="/ppt/charts/colors8.xml" ContentType="application/vnd.ms-office.chartcolorstyle+xml"/>
  <Override PartName="/ppt/charts/style8.xml" ContentType="application/vnd.ms-office.chartstyle+xml"/>
  <Override PartName="/ppt/charts/colors9.xml" ContentType="application/vnd.ms-office.chartcolorstyle+xml"/>
  <Override PartName="/ppt/charts/style9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000"/>
    <a:srgbClr val="CC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185" autoAdjust="0"/>
    <p:restoredTop sz="94660"/>
  </p:normalViewPr>
  <p:slideViewPr>
    <p:cSldViewPr snapToGrid="0">
      <p:cViewPr>
        <p:scale>
          <a:sx n="200" d="100"/>
          <a:sy n="200" d="100"/>
        </p:scale>
        <p:origin x="834" y="33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2.xm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3.xm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4.xm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5.xm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6.xm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7.xm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8.xm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ColorStyle" Target="colors9.xml"/><Relationship Id="rId2" Type="http://schemas.openxmlformats.org/officeDocument/2006/relationships/chartUserShapes" Target="../drawings/drawing8.xml"/><Relationship Id="rId1" Type="http://schemas.openxmlformats.org/officeDocument/2006/relationships/oleObject" Target="file:///C:\Users\ohmiya14\Desktop\&#12522;&#12450;&#12523;&#12479;&#12452;&#12512;PCR&#32080;&#26524;&#12288;2015\150909%20HCAR%20NOR%20W%20and%20G%20matome.xlsx" TargetMode="External"/><Relationship Id="rId4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C14-4894-9A0D-8035ED3CF600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C14-4894-9A0D-8035ED3CF60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C14-4894-9A0D-8035ED3CF60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C14-4894-9A0D-8035ED3CF600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CC14-4894-9A0D-8035ED3CF600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CC14-4894-9A0D-8035ED3CF600}"/>
              </c:ext>
            </c:extLst>
          </c:dPt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CC14-4894-9A0D-8035ED3CF600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CC14-4894-9A0D-8035ED3CF600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CC14-4894-9A0D-8035ED3CF600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CC14-4894-9A0D-8035ED3CF600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CC14-4894-9A0D-8035ED3CF600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E$2:$E$12</c:f>
                <c:numCache>
                  <c:formatCode>General</c:formatCode>
                  <c:ptCount val="11"/>
                  <c:pt idx="0">
                    <c:v>6.4037755295952466E-3</c:v>
                  </c:pt>
                  <c:pt idx="1">
                    <c:v>3.7158135090069031E-3</c:v>
                  </c:pt>
                  <c:pt idx="2">
                    <c:v>7.4074135400161532E-3</c:v>
                  </c:pt>
                  <c:pt idx="3">
                    <c:v>2.6918830282817108E-2</c:v>
                  </c:pt>
                  <c:pt idx="4">
                    <c:v>1.0421297615391708E-3</c:v>
                  </c:pt>
                  <c:pt idx="5">
                    <c:v>4.3922598865759315E-3</c:v>
                  </c:pt>
                  <c:pt idx="6">
                    <c:v>1.034178075248823E-2</c:v>
                  </c:pt>
                  <c:pt idx="7">
                    <c:v>4.6056795980443646E-3</c:v>
                  </c:pt>
                  <c:pt idx="8">
                    <c:v>5.9987355160794073E-3</c:v>
                  </c:pt>
                  <c:pt idx="9">
                    <c:v>3.3742848123924844E-3</c:v>
                  </c:pt>
                  <c:pt idx="10">
                    <c:v>1.662813455268478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2!$C$2:$C$12</c:f>
              <c:numCache>
                <c:formatCode>0.00E+00</c:formatCode>
                <c:ptCount val="11"/>
                <c:pt idx="0">
                  <c:v>2.6175368622257344E-2</c:v>
                </c:pt>
                <c:pt idx="1">
                  <c:v>2.191784225255991E-2</c:v>
                </c:pt>
                <c:pt idx="2">
                  <c:v>1.8236588632932774E-2</c:v>
                </c:pt>
                <c:pt idx="3">
                  <c:v>5.4976482512057362E-2</c:v>
                </c:pt>
                <c:pt idx="4">
                  <c:v>1.5408897097465077E-2</c:v>
                </c:pt>
                <c:pt idx="5">
                  <c:v>3.3916203853844723E-2</c:v>
                </c:pt>
                <c:pt idx="6">
                  <c:v>2.0177490628597586E-2</c:v>
                </c:pt>
                <c:pt idx="7">
                  <c:v>1.0628334928706516E-2</c:v>
                </c:pt>
                <c:pt idx="8">
                  <c:v>2.0638506592969837E-2</c:v>
                </c:pt>
                <c:pt idx="9">
                  <c:v>2.041869785736462E-2</c:v>
                </c:pt>
                <c:pt idx="10">
                  <c:v>5.072489120058065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6-CC14-4894-9A0D-8035ED3CF6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040384"/>
        <c:axId val="25041920"/>
      </c:barChart>
      <c:catAx>
        <c:axId val="2504038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041920"/>
        <c:crosses val="autoZero"/>
        <c:auto val="1"/>
        <c:lblAlgn val="ctr"/>
        <c:lblOffset val="100"/>
        <c:noMultiLvlLbl val="0"/>
      </c:catAx>
      <c:valAx>
        <c:axId val="25041920"/>
        <c:scaling>
          <c:orientation val="minMax"/>
          <c:max val="0.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040384"/>
        <c:crosses val="autoZero"/>
        <c:crossBetween val="between"/>
        <c:majorUnit val="2.0000000000000004E-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76E-478C-A97D-D0C0F1A78E8A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76E-478C-A97D-D0C0F1A78E8A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76E-478C-A97D-D0C0F1A78E8A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76E-478C-A97D-D0C0F1A78E8A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D76E-478C-A97D-D0C0F1A78E8A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I$2:$I$12</c:f>
                <c:numCache>
                  <c:formatCode>General</c:formatCode>
                  <c:ptCount val="11"/>
                  <c:pt idx="0">
                    <c:v>2.4661147087018366E-2</c:v>
                  </c:pt>
                  <c:pt idx="1">
                    <c:v>8.959750356574649E-3</c:v>
                  </c:pt>
                  <c:pt idx="2">
                    <c:v>1.3262245231760382E-2</c:v>
                  </c:pt>
                  <c:pt idx="3">
                    <c:v>1.5337458246178789E-2</c:v>
                  </c:pt>
                  <c:pt idx="4">
                    <c:v>8.1231723771888994E-4</c:v>
                  </c:pt>
                  <c:pt idx="5">
                    <c:v>1.6739559097769426E-2</c:v>
                  </c:pt>
                  <c:pt idx="6">
                    <c:v>5.3299904744716926E-3</c:v>
                  </c:pt>
                  <c:pt idx="7">
                    <c:v>1.0294685509871926E-2</c:v>
                  </c:pt>
                  <c:pt idx="8">
                    <c:v>1.2780323103094925E-2</c:v>
                  </c:pt>
                  <c:pt idx="9">
                    <c:v>1.095172901317194E-2</c:v>
                  </c:pt>
                  <c:pt idx="10">
                    <c:v>1.107116577092036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2!$G$2:$G$12</c:f>
              <c:numCache>
                <c:formatCode>0.00E+00</c:formatCode>
                <c:ptCount val="11"/>
                <c:pt idx="0">
                  <c:v>5.6535359010751851E-2</c:v>
                </c:pt>
                <c:pt idx="1">
                  <c:v>3.8006505429935472E-2</c:v>
                </c:pt>
                <c:pt idx="2">
                  <c:v>3.2850249227587835E-2</c:v>
                </c:pt>
                <c:pt idx="3">
                  <c:v>5.5949173777518471E-2</c:v>
                </c:pt>
                <c:pt idx="4">
                  <c:v>4.5026303223678892E-2</c:v>
                </c:pt>
                <c:pt idx="5">
                  <c:v>5.7690608007628402E-2</c:v>
                </c:pt>
                <c:pt idx="6">
                  <c:v>6.9740725427694439E-2</c:v>
                </c:pt>
                <c:pt idx="7">
                  <c:v>1.3853545031480974E-2</c:v>
                </c:pt>
                <c:pt idx="8">
                  <c:v>3.448271606178744E-2</c:v>
                </c:pt>
                <c:pt idx="9">
                  <c:v>3.6994770038051884E-2</c:v>
                </c:pt>
                <c:pt idx="10">
                  <c:v>5.1910128604955273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D76E-478C-A97D-D0C0F1A78E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070976"/>
        <c:axId val="25076864"/>
      </c:barChart>
      <c:catAx>
        <c:axId val="250709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076864"/>
        <c:crosses val="autoZero"/>
        <c:auto val="1"/>
        <c:lblAlgn val="ctr"/>
        <c:lblOffset val="100"/>
        <c:noMultiLvlLbl val="0"/>
      </c:catAx>
      <c:valAx>
        <c:axId val="25076864"/>
        <c:scaling>
          <c:orientation val="minMax"/>
          <c:max val="0.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070976"/>
        <c:crosses val="autoZero"/>
        <c:crossBetween val="between"/>
        <c:majorUnit val="2.0000000000000004E-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1FB-4434-8467-AFE6107BA506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1FB-4434-8467-AFE6107BA506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1FB-4434-8467-AFE6107BA506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1FB-4434-8467-AFE6107BA506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1FB-4434-8467-AFE6107BA506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M$2:$M$12</c:f>
                <c:numCache>
                  <c:formatCode>General</c:formatCode>
                  <c:ptCount val="11"/>
                  <c:pt idx="0">
                    <c:v>2.0922572922637547E-2</c:v>
                  </c:pt>
                  <c:pt idx="1">
                    <c:v>6.4644989866545037E-3</c:v>
                  </c:pt>
                  <c:pt idx="2">
                    <c:v>2.8643533550850177E-2</c:v>
                  </c:pt>
                  <c:pt idx="3">
                    <c:v>3.6485484209067762E-2</c:v>
                  </c:pt>
                  <c:pt idx="4">
                    <c:v>3.6046625272500746E-3</c:v>
                  </c:pt>
                  <c:pt idx="5">
                    <c:v>1.3848250767191922E-2</c:v>
                  </c:pt>
                  <c:pt idx="6">
                    <c:v>2.2996680600195215E-2</c:v>
                  </c:pt>
                  <c:pt idx="7">
                    <c:v>2.3566995510375128E-2</c:v>
                  </c:pt>
                  <c:pt idx="8">
                    <c:v>2.1594199947955695E-2</c:v>
                  </c:pt>
                  <c:pt idx="9">
                    <c:v>4.2521520623611829E-2</c:v>
                  </c:pt>
                  <c:pt idx="10">
                    <c:v>3.216904337866162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2!$K$2:$K$12</c:f>
              <c:numCache>
                <c:formatCode>0.00E+00</c:formatCode>
                <c:ptCount val="11"/>
                <c:pt idx="0">
                  <c:v>6.5249461324398739E-2</c:v>
                </c:pt>
                <c:pt idx="1">
                  <c:v>4.4210803064224369E-2</c:v>
                </c:pt>
                <c:pt idx="2">
                  <c:v>6.4623039434925908E-2</c:v>
                </c:pt>
                <c:pt idx="3">
                  <c:v>0.10604254906867329</c:v>
                </c:pt>
                <c:pt idx="4">
                  <c:v>5.126228937145675E-2</c:v>
                </c:pt>
                <c:pt idx="5">
                  <c:v>6.9655656456138998E-2</c:v>
                </c:pt>
                <c:pt idx="6">
                  <c:v>5.2356070685658174E-2</c:v>
                </c:pt>
                <c:pt idx="7">
                  <c:v>4.6285048926895396E-2</c:v>
                </c:pt>
                <c:pt idx="8">
                  <c:v>6.8319183610647885E-2</c:v>
                </c:pt>
                <c:pt idx="9">
                  <c:v>9.8156789127680902E-2</c:v>
                </c:pt>
                <c:pt idx="10">
                  <c:v>7.779178508039776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E1FB-4434-8467-AFE6107BA5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097728"/>
        <c:axId val="25099264"/>
      </c:barChart>
      <c:catAx>
        <c:axId val="2509772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099264"/>
        <c:crosses val="autoZero"/>
        <c:auto val="1"/>
        <c:lblAlgn val="ctr"/>
        <c:lblOffset val="100"/>
        <c:noMultiLvlLbl val="0"/>
      </c:catAx>
      <c:valAx>
        <c:axId val="25099264"/>
        <c:scaling>
          <c:orientation val="minMax"/>
          <c:max val="0.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097728"/>
        <c:crosses val="autoZero"/>
        <c:crossBetween val="between"/>
        <c:majorUnit val="5.000000000000001E-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A7A-4888-8BEE-34FA59FC5557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A7A-4888-8BEE-34FA59FC5557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A7A-4888-8BEE-34FA59FC5557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A7A-4888-8BEE-34FA59FC5557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8A7A-4888-8BEE-34FA59FC5557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Q$2:$Q$12</c:f>
                <c:numCache>
                  <c:formatCode>General</c:formatCode>
                  <c:ptCount val="11"/>
                  <c:pt idx="0">
                    <c:v>15.315465429676379</c:v>
                  </c:pt>
                  <c:pt idx="1">
                    <c:v>4.1976402402734481</c:v>
                  </c:pt>
                  <c:pt idx="2">
                    <c:v>3.8534490936926153</c:v>
                  </c:pt>
                  <c:pt idx="3">
                    <c:v>4.9421560886889679</c:v>
                  </c:pt>
                  <c:pt idx="4">
                    <c:v>14.60844750343685</c:v>
                  </c:pt>
                  <c:pt idx="5">
                    <c:v>18.39596103943617</c:v>
                  </c:pt>
                  <c:pt idx="6">
                    <c:v>30.139163894987473</c:v>
                  </c:pt>
                  <c:pt idx="7">
                    <c:v>20.912956762874945</c:v>
                  </c:pt>
                  <c:pt idx="8">
                    <c:v>6.220250759888339</c:v>
                  </c:pt>
                  <c:pt idx="9">
                    <c:v>9.5161807276699353</c:v>
                  </c:pt>
                  <c:pt idx="10">
                    <c:v>11.2480841246025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2!$O$2:$O$12</c:f>
              <c:numCache>
                <c:formatCode>0.00E+00</c:formatCode>
                <c:ptCount val="11"/>
                <c:pt idx="0">
                  <c:v>57.073055146440403</c:v>
                </c:pt>
                <c:pt idx="1">
                  <c:v>22.781367965520257</c:v>
                </c:pt>
                <c:pt idx="2">
                  <c:v>50.673915074668052</c:v>
                </c:pt>
                <c:pt idx="3">
                  <c:v>39.578571439936105</c:v>
                </c:pt>
                <c:pt idx="4">
                  <c:v>28.749794601341751</c:v>
                </c:pt>
                <c:pt idx="5">
                  <c:v>53.402799821889907</c:v>
                </c:pt>
                <c:pt idx="6">
                  <c:v>57.828521568079616</c:v>
                </c:pt>
                <c:pt idx="7">
                  <c:v>65.579896412774005</c:v>
                </c:pt>
                <c:pt idx="8">
                  <c:v>18.943433469092849</c:v>
                </c:pt>
                <c:pt idx="9">
                  <c:v>24.033825966741109</c:v>
                </c:pt>
                <c:pt idx="10">
                  <c:v>39.8056928229545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A7A-4888-8BEE-34FA59FC55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124224"/>
        <c:axId val="25126016"/>
      </c:barChart>
      <c:catAx>
        <c:axId val="2512422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126016"/>
        <c:crosses val="autoZero"/>
        <c:auto val="1"/>
        <c:lblAlgn val="ctr"/>
        <c:lblOffset val="100"/>
        <c:noMultiLvlLbl val="0"/>
      </c:catAx>
      <c:valAx>
        <c:axId val="251260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124224"/>
        <c:crosses val="autoZero"/>
        <c:crossBetween val="between"/>
        <c:majorUnit val="20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87DB-4DD8-A2E1-5F1BB7E43CDD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7DB-4DD8-A2E1-5F1BB7E43CDD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7DB-4DD8-A2E1-5F1BB7E43CDD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7DB-4DD8-A2E1-5F1BB7E43CDD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87DB-4DD8-A2E1-5F1BB7E43CD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Q$2:$Q$12</c:f>
                <c:numCache>
                  <c:formatCode>General</c:formatCode>
                  <c:ptCount val="11"/>
                  <c:pt idx="0">
                    <c:v>2.86234012812256E-3</c:v>
                  </c:pt>
                  <c:pt idx="1">
                    <c:v>6.2602492603751596E-4</c:v>
                  </c:pt>
                  <c:pt idx="2">
                    <c:v>3.0606882404303E-3</c:v>
                  </c:pt>
                  <c:pt idx="3">
                    <c:v>5.87842831607625E-3</c:v>
                  </c:pt>
                  <c:pt idx="4">
                    <c:v>7.6335379193552305E-4</c:v>
                  </c:pt>
                  <c:pt idx="5">
                    <c:v>9.3162076854161997E-4</c:v>
                  </c:pt>
                  <c:pt idx="6">
                    <c:v>1.3847830729417901E-3</c:v>
                  </c:pt>
                  <c:pt idx="7">
                    <c:v>3.7127692041289198E-4</c:v>
                  </c:pt>
                  <c:pt idx="8">
                    <c:v>4.12878492091962E-3</c:v>
                  </c:pt>
                  <c:pt idx="9">
                    <c:v>6.0930508958993495E-4</c:v>
                  </c:pt>
                  <c:pt idx="10">
                    <c:v>5.1745057933710295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1!$O$2:$O$12</c:f>
              <c:numCache>
                <c:formatCode>0.0000_);[Red]\(0.0000\)</c:formatCode>
                <c:ptCount val="11"/>
                <c:pt idx="0">
                  <c:v>9.8405377771544691E-3</c:v>
                </c:pt>
                <c:pt idx="1">
                  <c:v>3.0980725319497298E-3</c:v>
                </c:pt>
                <c:pt idx="2">
                  <c:v>8.66872887085216E-3</c:v>
                </c:pt>
                <c:pt idx="3">
                  <c:v>1.14908624458378E-2</c:v>
                </c:pt>
                <c:pt idx="4">
                  <c:v>4.3434474949189698E-3</c:v>
                </c:pt>
                <c:pt idx="5">
                  <c:v>5.4787865609026501E-3</c:v>
                </c:pt>
                <c:pt idx="6">
                  <c:v>2.7009647489671601E-3</c:v>
                </c:pt>
                <c:pt idx="7">
                  <c:v>4.34678266823957E-3</c:v>
                </c:pt>
                <c:pt idx="8">
                  <c:v>1.1862226375067699E-2</c:v>
                </c:pt>
                <c:pt idx="9">
                  <c:v>5.9517249219323103E-3</c:v>
                </c:pt>
                <c:pt idx="10">
                  <c:v>3.2024681417299901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7DB-4DD8-A2E1-5F1BB7E43C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150976"/>
        <c:axId val="25152512"/>
      </c:barChart>
      <c:catAx>
        <c:axId val="251509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152512"/>
        <c:crosses val="autoZero"/>
        <c:auto val="1"/>
        <c:lblAlgn val="ctr"/>
        <c:lblOffset val="100"/>
        <c:noMultiLvlLbl val="0"/>
      </c:catAx>
      <c:valAx>
        <c:axId val="251525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0_);[Red]\(#,##0.0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150976"/>
        <c:crosses val="autoZero"/>
        <c:crossBetween val="between"/>
        <c:majorUnit val="5.000000000000001E-3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15B4-4C7A-BA69-7FD97A32C4CC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15B4-4C7A-BA69-7FD97A32C4CC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15B4-4C7A-BA69-7FD97A32C4CC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15B4-4C7A-BA69-7FD97A32C4CC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15B4-4C7A-BA69-7FD97A32C4C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U$2:$U$12</c:f>
                <c:numCache>
                  <c:formatCode>General</c:formatCode>
                  <c:ptCount val="11"/>
                  <c:pt idx="0">
                    <c:v>4.3894121550556199E-3</c:v>
                  </c:pt>
                  <c:pt idx="1">
                    <c:v>2.1180264314390098E-3</c:v>
                  </c:pt>
                  <c:pt idx="2">
                    <c:v>1.51991115669325E-2</c:v>
                  </c:pt>
                  <c:pt idx="3">
                    <c:v>1.9029445384558901E-2</c:v>
                  </c:pt>
                  <c:pt idx="4">
                    <c:v>6.5534539580209097E-4</c:v>
                  </c:pt>
                  <c:pt idx="5">
                    <c:v>4.6227985639459897E-3</c:v>
                  </c:pt>
                  <c:pt idx="6">
                    <c:v>4.5762317369762101E-3</c:v>
                  </c:pt>
                  <c:pt idx="7">
                    <c:v>5.6329621278946203E-3</c:v>
                  </c:pt>
                  <c:pt idx="8">
                    <c:v>2.7862082088732499E-3</c:v>
                  </c:pt>
                  <c:pt idx="9">
                    <c:v>3.9869973297706101E-3</c:v>
                  </c:pt>
                  <c:pt idx="10">
                    <c:v>2.6055902605820699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1!$S$2:$S$12</c:f>
              <c:numCache>
                <c:formatCode>0.0000_);[Red]\(0.0000\)</c:formatCode>
                <c:ptCount val="11"/>
                <c:pt idx="0">
                  <c:v>2.6797942990771099E-2</c:v>
                </c:pt>
                <c:pt idx="1">
                  <c:v>1.3892550963732E-2</c:v>
                </c:pt>
                <c:pt idx="2">
                  <c:v>3.7057697000193103E-2</c:v>
                </c:pt>
                <c:pt idx="3">
                  <c:v>4.9803196017202997E-2</c:v>
                </c:pt>
                <c:pt idx="4">
                  <c:v>2.4005152530287399E-2</c:v>
                </c:pt>
                <c:pt idx="5">
                  <c:v>2.0827204514933299E-2</c:v>
                </c:pt>
                <c:pt idx="6">
                  <c:v>9.78484679731614E-3</c:v>
                </c:pt>
                <c:pt idx="7">
                  <c:v>1.0836638003190201E-2</c:v>
                </c:pt>
                <c:pt idx="8">
                  <c:v>2.2060131509693499E-2</c:v>
                </c:pt>
                <c:pt idx="9">
                  <c:v>1.6495046063318201E-2</c:v>
                </c:pt>
                <c:pt idx="10">
                  <c:v>1.8710585497061599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15B4-4C7A-BA69-7FD97A32C4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177472"/>
        <c:axId val="25179264"/>
      </c:barChart>
      <c:catAx>
        <c:axId val="2517747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179264"/>
        <c:crosses val="autoZero"/>
        <c:auto val="1"/>
        <c:lblAlgn val="ctr"/>
        <c:lblOffset val="100"/>
        <c:noMultiLvlLbl val="0"/>
      </c:catAx>
      <c:valAx>
        <c:axId val="2517926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_);[Red]\(#,##0.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177472"/>
        <c:crosses val="autoZero"/>
        <c:crossBetween val="between"/>
        <c:majorUnit val="2.0000000000000004E-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B13-4463-8A8E-8D89CDEC93D0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B13-4463-8A8E-8D89CDEC93D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B13-4463-8A8E-8D89CDEC93D0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5B13-4463-8A8E-8D89CDEC93D0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5B13-4463-8A8E-8D89CDEC93D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Y$1:$Y$12</c:f>
                <c:numCache>
                  <c:formatCode>General</c:formatCode>
                  <c:ptCount val="12"/>
                  <c:pt idx="0">
                    <c:v>0</c:v>
                  </c:pt>
                  <c:pt idx="1">
                    <c:v>3.6409234503768402E-6</c:v>
                  </c:pt>
                  <c:pt idx="2">
                    <c:v>6.4070394273090902E-4</c:v>
                  </c:pt>
                  <c:pt idx="3">
                    <c:v>2.0924551834976398E-3</c:v>
                  </c:pt>
                  <c:pt idx="4">
                    <c:v>1.1770310248478E-4</c:v>
                  </c:pt>
                  <c:pt idx="5">
                    <c:v>2.8619282223088216E-6</c:v>
                  </c:pt>
                  <c:pt idx="6">
                    <c:v>2.8789383688942701E-4</c:v>
                  </c:pt>
                  <c:pt idx="7">
                    <c:v>4.5045881345400903E-5</c:v>
                  </c:pt>
                  <c:pt idx="8">
                    <c:v>7.5380286470986405E-5</c:v>
                  </c:pt>
                  <c:pt idx="9">
                    <c:v>9.6841550621949596E-5</c:v>
                  </c:pt>
                  <c:pt idx="10">
                    <c:v>9.81029764704533E-4</c:v>
                  </c:pt>
                  <c:pt idx="11">
                    <c:v>5.1138933697259198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1!$W$2:$W$12</c:f>
              <c:numCache>
                <c:formatCode>0.0000000_);[Red]\(0.0000000\)</c:formatCode>
                <c:ptCount val="11"/>
                <c:pt idx="0">
                  <c:v>8.0186678363253002E-5</c:v>
                </c:pt>
                <c:pt idx="1">
                  <c:v>1.7901456291914801E-3</c:v>
                </c:pt>
                <c:pt idx="2">
                  <c:v>5.3011393647256003E-3</c:v>
                </c:pt>
                <c:pt idx="3">
                  <c:v>2.5127104946348101E-4</c:v>
                </c:pt>
                <c:pt idx="4">
                  <c:v>4.9862723106734795E-4</c:v>
                </c:pt>
                <c:pt idx="5">
                  <c:v>4.7261580522780101E-4</c:v>
                </c:pt>
                <c:pt idx="6">
                  <c:v>5.0215115839666899E-5</c:v>
                </c:pt>
                <c:pt idx="7">
                  <c:v>1.5028684004754901E-4</c:v>
                </c:pt>
                <c:pt idx="8">
                  <c:v>1.86154134750561E-4</c:v>
                </c:pt>
                <c:pt idx="9">
                  <c:v>4.3660071256155604E-3</c:v>
                </c:pt>
                <c:pt idx="10">
                  <c:v>1.10924098604039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5B13-4463-8A8E-8D89CDEC93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235840"/>
        <c:axId val="25237376"/>
      </c:barChart>
      <c:catAx>
        <c:axId val="25235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237376"/>
        <c:crosses val="autoZero"/>
        <c:auto val="1"/>
        <c:lblAlgn val="ctr"/>
        <c:lblOffset val="100"/>
        <c:noMultiLvlLbl val="0"/>
      </c:catAx>
      <c:valAx>
        <c:axId val="25237376"/>
        <c:scaling>
          <c:orientation val="minMax"/>
          <c:max val="8.0000000000000019E-3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00_);[Red]\(#,##0.00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235840"/>
        <c:crosses val="autoZero"/>
        <c:crossBetween val="between"/>
        <c:majorUnit val="2.0000000000000005E-3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6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010-47FB-B157-2C532287771B}"/>
              </c:ext>
            </c:extLst>
          </c:dPt>
          <c:dPt>
            <c:idx val="7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010-47FB-B157-2C532287771B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010-47FB-B157-2C532287771B}"/>
              </c:ext>
            </c:extLst>
          </c:dPt>
          <c:dPt>
            <c:idx val="9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3010-47FB-B157-2C532287771B}"/>
              </c:ext>
            </c:extLst>
          </c:dPt>
          <c:dPt>
            <c:idx val="10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3010-47FB-B157-2C532287771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AC$2:$AC$12</c:f>
                <c:numCache>
                  <c:formatCode>General</c:formatCode>
                  <c:ptCount val="11"/>
                  <c:pt idx="0">
                    <c:v>1.99685842401464E-2</c:v>
                  </c:pt>
                  <c:pt idx="1">
                    <c:v>1.8625716200784399E-4</c:v>
                  </c:pt>
                  <c:pt idx="2">
                    <c:v>4.1317416284947998E-2</c:v>
                  </c:pt>
                  <c:pt idx="3">
                    <c:v>1.9630175646274301E-2</c:v>
                  </c:pt>
                  <c:pt idx="4">
                    <c:v>9.3188753332373794E-3</c:v>
                  </c:pt>
                  <c:pt idx="5">
                    <c:v>0.24003307273452601</c:v>
                  </c:pt>
                  <c:pt idx="6">
                    <c:v>8.1071554654667297E-2</c:v>
                  </c:pt>
                  <c:pt idx="7">
                    <c:v>0.17556738432146601</c:v>
                  </c:pt>
                  <c:pt idx="8">
                    <c:v>2.1440521995181001E-2</c:v>
                  </c:pt>
                  <c:pt idx="9">
                    <c:v>9.5781980640902695E-2</c:v>
                  </c:pt>
                  <c:pt idx="10">
                    <c:v>2.19371629557396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12</c:f>
              <c:strCache>
                <c:ptCount val="11"/>
                <c:pt idx="0">
                  <c:v>ES</c:v>
                </c:pt>
                <c:pt idx="1">
                  <c:v>BT</c:v>
                </c:pt>
                <c:pt idx="2">
                  <c:v>SP</c:v>
                </c:pt>
                <c:pt idx="3">
                  <c:v>SE</c:v>
                </c:pt>
                <c:pt idx="4">
                  <c:v>RD</c:v>
                </c:pt>
                <c:pt idx="5">
                  <c:v>FR</c:v>
                </c:pt>
                <c:pt idx="6">
                  <c:v>GN</c:v>
                </c:pt>
                <c:pt idx="7">
                  <c:v>GR</c:v>
                </c:pt>
                <c:pt idx="8">
                  <c:v>AG</c:v>
                </c:pt>
                <c:pt idx="9">
                  <c:v>OL</c:v>
                </c:pt>
                <c:pt idx="10">
                  <c:v>GL</c:v>
                </c:pt>
              </c:strCache>
            </c:strRef>
          </c:cat>
          <c:val>
            <c:numRef>
              <c:f>Sheet1!$AA$2:$AA$12</c:f>
              <c:numCache>
                <c:formatCode>0.0000_);[Red]\(0.0000\)</c:formatCode>
                <c:ptCount val="11"/>
                <c:pt idx="0">
                  <c:v>0.101131636844714</c:v>
                </c:pt>
                <c:pt idx="1">
                  <c:v>1.4914564487502899E-3</c:v>
                </c:pt>
                <c:pt idx="2">
                  <c:v>0.29254773112735399</c:v>
                </c:pt>
                <c:pt idx="3">
                  <c:v>9.9230620106813799E-2</c:v>
                </c:pt>
                <c:pt idx="4">
                  <c:v>1.7186412435601001E-2</c:v>
                </c:pt>
                <c:pt idx="5">
                  <c:v>0.45872832385068602</c:v>
                </c:pt>
                <c:pt idx="6">
                  <c:v>0.16707736522615199</c:v>
                </c:pt>
                <c:pt idx="7">
                  <c:v>0.745651375661736</c:v>
                </c:pt>
                <c:pt idx="8">
                  <c:v>6.0444068743500799E-2</c:v>
                </c:pt>
                <c:pt idx="9">
                  <c:v>0.324460567162002</c:v>
                </c:pt>
                <c:pt idx="10">
                  <c:v>0.15680646496168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3010-47FB-B157-2C53228777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5266432"/>
        <c:axId val="25268224"/>
      </c:barChart>
      <c:catAx>
        <c:axId val="252664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5268224"/>
        <c:crosses val="autoZero"/>
        <c:auto val="1"/>
        <c:lblAlgn val="ctr"/>
        <c:lblOffset val="100"/>
        <c:noMultiLvlLbl val="0"/>
      </c:catAx>
      <c:valAx>
        <c:axId val="2526822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5266432"/>
        <c:crosses val="autoZero"/>
        <c:crossBetween val="between"/>
        <c:majorUnit val="0.2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  <c:userShapes r:id="rId2"/>
</c:chartSpac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7527</cdr:x>
      <cdr:y>0.09227</cdr:y>
    </cdr:from>
    <cdr:to>
      <cdr:x>0.43508</cdr:x>
      <cdr:y>0.45318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57766" y="114784"/>
          <a:ext cx="530327" cy="44896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NAC057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6207</cdr:x>
      <cdr:y>0.06909</cdr:y>
    </cdr:from>
    <cdr:to>
      <cdr:x>0.41305</cdr:x>
      <cdr:y>0.43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30828" y="85425"/>
          <a:ext cx="512302" cy="44619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NTL8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8389</cdr:x>
      <cdr:y>0.08392</cdr:y>
    </cdr:from>
    <cdr:to>
      <cdr:x>0.42122</cdr:x>
      <cdr:y>0.44618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75357" y="104559"/>
          <a:ext cx="484440" cy="4513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SHN3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5553</cdr:x>
      <cdr:y>0.07972</cdr:y>
    </cdr:from>
    <cdr:to>
      <cdr:x>0.38465</cdr:x>
      <cdr:y>0.4352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12276" y="98719"/>
          <a:ext cx="460043" cy="4402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MIF2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8461</cdr:x>
      <cdr:y>0.07394</cdr:y>
    </cdr:from>
    <cdr:to>
      <cdr:x>0.38188</cdr:x>
      <cdr:y>0.3953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87148" y="91232"/>
          <a:ext cx="413692" cy="3966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MYB4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6673</cdr:x>
      <cdr:y>0.07784</cdr:y>
    </cdr:from>
    <cdr:to>
      <cdr:x>0.36673</cdr:x>
      <cdr:y>0.41117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39328" y="96388"/>
          <a:ext cx="407035" cy="4127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MYB3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888</cdr:x>
      <cdr:y>0.0713</cdr:y>
    </cdr:from>
    <cdr:to>
      <cdr:x>0.3888</cdr:x>
      <cdr:y>0.40463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96947" y="88214"/>
          <a:ext cx="420497" cy="4124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OFP6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16146</cdr:x>
      <cdr:y>0.08581</cdr:y>
    </cdr:from>
    <cdr:to>
      <cdr:x>0.36146</cdr:x>
      <cdr:y>0.41915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321013" y="106668"/>
          <a:ext cx="397637" cy="4143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000" i="1" dirty="0">
              <a:latin typeface="Arial" panose="020B0604020202020204" pitchFamily="34" charset="0"/>
              <a:cs typeface="Arial" panose="020B0604020202020204" pitchFamily="34" charset="0"/>
            </a:rPr>
            <a:t>HB40</a:t>
          </a:r>
          <a:endParaRPr lang="ja-JP" altLang="en-US" sz="1000" i="1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1679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8874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72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281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9993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6190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643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8549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008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68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8951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F4296-DDB8-436A-88EF-B20F3C9331B3}" type="datetimeFigureOut">
              <a:rPr kumimoji="1" lang="ja-JP" altLang="en-US" smtClean="0"/>
              <a:t>2017/1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6AD4A-22B2-4F77-BCF4-6DC2DBF301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3050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0871932"/>
              </p:ext>
            </p:extLst>
          </p:nvPr>
        </p:nvGraphicFramePr>
        <p:xfrm>
          <a:off x="1698333" y="1925159"/>
          <a:ext cx="2041208" cy="12439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5943135"/>
              </p:ext>
            </p:extLst>
          </p:nvPr>
        </p:nvGraphicFramePr>
        <p:xfrm>
          <a:off x="1692209" y="3052647"/>
          <a:ext cx="2041207" cy="12363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1527105"/>
              </p:ext>
            </p:extLst>
          </p:nvPr>
        </p:nvGraphicFramePr>
        <p:xfrm>
          <a:off x="1698333" y="4234426"/>
          <a:ext cx="2041208" cy="12458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9021209"/>
              </p:ext>
            </p:extLst>
          </p:nvPr>
        </p:nvGraphicFramePr>
        <p:xfrm>
          <a:off x="1720104" y="5368038"/>
          <a:ext cx="2007869" cy="12382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/>
          </p:nvPr>
        </p:nvGraphicFramePr>
        <p:xfrm>
          <a:off x="3565143" y="3050983"/>
          <a:ext cx="2097088" cy="12339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/>
          </p:nvPr>
        </p:nvGraphicFramePr>
        <p:xfrm>
          <a:off x="3641342" y="1919985"/>
          <a:ext cx="2035175" cy="1238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2190986"/>
              </p:ext>
            </p:extLst>
          </p:nvPr>
        </p:nvGraphicFramePr>
        <p:xfrm>
          <a:off x="3567228" y="4226670"/>
          <a:ext cx="2102485" cy="12372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9407753"/>
              </p:ext>
            </p:extLst>
          </p:nvPr>
        </p:nvGraphicFramePr>
        <p:xfrm>
          <a:off x="3686972" y="5368036"/>
          <a:ext cx="1988184" cy="1243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 rot="16200000">
            <a:off x="812300" y="4136949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024668" y="6471116"/>
            <a:ext cx="16594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2  3  4  5  6  7  8  9  10  1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973212" y="6471115"/>
            <a:ext cx="16594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  2  3  4  5  6  7  8  9  10  11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グループ化 28"/>
          <p:cNvGrpSpPr/>
          <p:nvPr/>
        </p:nvGrpSpPr>
        <p:grpSpPr>
          <a:xfrm>
            <a:off x="1873981" y="6708819"/>
            <a:ext cx="2015693" cy="409539"/>
            <a:chOff x="3585135" y="6597637"/>
            <a:chExt cx="2015693" cy="409539"/>
          </a:xfrm>
        </p:grpSpPr>
        <p:sp>
          <p:nvSpPr>
            <p:cNvPr id="30" name="テキスト ボックス 29"/>
            <p:cNvSpPr txBox="1"/>
            <p:nvPr/>
          </p:nvSpPr>
          <p:spPr>
            <a:xfrm>
              <a:off x="4500847" y="6597637"/>
              <a:ext cx="10999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reen-flowered 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ultiv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3585135" y="6607066"/>
              <a:ext cx="10727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hite-flowered 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ultiv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線コネクタ 31"/>
            <p:cNvCxnSpPr/>
            <p:nvPr/>
          </p:nvCxnSpPr>
          <p:spPr>
            <a:xfrm>
              <a:off x="3832860" y="6607390"/>
              <a:ext cx="713708" cy="25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/>
            <p:cNvCxnSpPr/>
            <p:nvPr/>
          </p:nvCxnSpPr>
          <p:spPr>
            <a:xfrm>
              <a:off x="4613910" y="6611200"/>
              <a:ext cx="659130" cy="272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グループ化 33"/>
          <p:cNvGrpSpPr/>
          <p:nvPr/>
        </p:nvGrpSpPr>
        <p:grpSpPr>
          <a:xfrm>
            <a:off x="3805651" y="6708819"/>
            <a:ext cx="2015693" cy="409539"/>
            <a:chOff x="3585135" y="6597637"/>
            <a:chExt cx="2015693" cy="409539"/>
          </a:xfrm>
        </p:grpSpPr>
        <p:sp>
          <p:nvSpPr>
            <p:cNvPr id="35" name="テキスト ボックス 34"/>
            <p:cNvSpPr txBox="1"/>
            <p:nvPr/>
          </p:nvSpPr>
          <p:spPr>
            <a:xfrm>
              <a:off x="4500847" y="6597637"/>
              <a:ext cx="109998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Green-flowered 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ultiv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3585135" y="6607066"/>
              <a:ext cx="10727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White-flowered </a:t>
              </a:r>
            </a:p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cultivars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直線コネクタ 36"/>
            <p:cNvCxnSpPr/>
            <p:nvPr/>
          </p:nvCxnSpPr>
          <p:spPr>
            <a:xfrm>
              <a:off x="3832860" y="6607390"/>
              <a:ext cx="713708" cy="25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/>
            <p:cNvCxnSpPr/>
            <p:nvPr/>
          </p:nvCxnSpPr>
          <p:spPr>
            <a:xfrm>
              <a:off x="4613910" y="6611200"/>
              <a:ext cx="659130" cy="272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テキスト ボックス 42"/>
          <p:cNvSpPr txBox="1"/>
          <p:nvPr/>
        </p:nvSpPr>
        <p:spPr>
          <a:xfrm>
            <a:off x="4658973" y="50953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803092" y="60637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183814" y="58914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5345737" y="612475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4389288" y="48736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241609" y="445095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174815" y="462357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046697" y="4934772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a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4527927" y="508214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4938712" y="542468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3977975" y="61839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4228856" y="59735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5314706" y="4897157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 err="1">
                <a:latin typeface="Arial" panose="020B0604020202020204" pitchFamily="34" charset="0"/>
                <a:cs typeface="Arial" panose="020B0604020202020204" pitchFamily="34" charset="0"/>
              </a:rPr>
              <a:t>b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967730" y="515100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4120850" y="62934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4392066" y="61851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4523454" y="62686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4634439" y="56163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5073349" y="62220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792323" y="51191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4930436" y="512387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/>
          <p:cNvSpPr txBox="1"/>
          <p:nvPr/>
        </p:nvSpPr>
        <p:spPr>
          <a:xfrm>
            <a:off x="5063786" y="51191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2731611" y="47648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588735" y="48982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2450623" y="44743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2317273" y="471248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2179161" y="49267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2041048" y="47458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2036286" y="55840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417410" y="46315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/>
          <p:cNvSpPr txBox="1"/>
          <p:nvPr/>
        </p:nvSpPr>
        <p:spPr>
          <a:xfrm>
            <a:off x="3279298" y="44838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3136423" y="47362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3003073" y="48363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2864961" y="47982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2717323" y="55983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2579210" y="58840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445860" y="58697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312510" y="57602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2169636" y="60269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403123" y="57935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3260248" y="59697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3126898" y="60555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2993548" y="546496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2850673" y="54459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2445611" y="32870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174148" y="352041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2312261" y="35280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5345974" y="25850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2855186" y="32518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2717074" y="32565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2126523" y="32613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2588486" y="35280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3407636" y="33708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3264761" y="351852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3136174" y="35232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2998061" y="37471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/>
          <p:cNvSpPr txBox="1"/>
          <p:nvPr/>
        </p:nvSpPr>
        <p:spPr>
          <a:xfrm>
            <a:off x="4512536" y="37233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4379186" y="31470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/>
          <p:cNvSpPr txBox="1"/>
          <p:nvPr/>
        </p:nvSpPr>
        <p:spPr>
          <a:xfrm>
            <a:off x="4236311" y="34137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/>
          <p:cNvSpPr txBox="1"/>
          <p:nvPr/>
        </p:nvSpPr>
        <p:spPr>
          <a:xfrm>
            <a:off x="4098198" y="37899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>
            <a:off x="3969611" y="33518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>
            <a:off x="5060224" y="32089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/>
          <p:cNvSpPr txBox="1"/>
          <p:nvPr/>
        </p:nvSpPr>
        <p:spPr>
          <a:xfrm>
            <a:off x="4926874" y="37518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/>
          <p:cNvSpPr txBox="1"/>
          <p:nvPr/>
        </p:nvSpPr>
        <p:spPr>
          <a:xfrm>
            <a:off x="4783998" y="37756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4650648" y="36661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/>
          <p:cNvSpPr txBox="1"/>
          <p:nvPr/>
        </p:nvSpPr>
        <p:spPr>
          <a:xfrm>
            <a:off x="2178911" y="26136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/>
          <p:cNvSpPr txBox="1"/>
          <p:nvPr/>
        </p:nvSpPr>
        <p:spPr>
          <a:xfrm>
            <a:off x="2036036" y="253744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5336449" y="37947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5198336" y="36661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/>
          <p:cNvSpPr txBox="1"/>
          <p:nvPr/>
        </p:nvSpPr>
        <p:spPr>
          <a:xfrm>
            <a:off x="2869474" y="25564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/>
          <p:cNvSpPr txBox="1"/>
          <p:nvPr/>
        </p:nvSpPr>
        <p:spPr>
          <a:xfrm>
            <a:off x="2731361" y="24850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2593248" y="26993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2312261" y="25993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3983899" y="24707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3274286" y="26326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/>
          <p:cNvSpPr txBox="1"/>
          <p:nvPr/>
        </p:nvSpPr>
        <p:spPr>
          <a:xfrm>
            <a:off x="3140936" y="26041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>
            <a:off x="2998061" y="27088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>
            <a:off x="3412398" y="22040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/>
          <p:cNvSpPr txBox="1"/>
          <p:nvPr/>
        </p:nvSpPr>
        <p:spPr>
          <a:xfrm>
            <a:off x="2455136" y="206596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/>
          <p:cNvSpPr txBox="1"/>
          <p:nvPr/>
        </p:nvSpPr>
        <p:spPr>
          <a:xfrm>
            <a:off x="4393474" y="20183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>
            <a:off x="4260124" y="22135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/>
          <p:cNvSpPr txBox="1"/>
          <p:nvPr/>
        </p:nvSpPr>
        <p:spPr>
          <a:xfrm>
            <a:off x="4122011" y="26612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/>
          <p:cNvSpPr txBox="1"/>
          <p:nvPr/>
        </p:nvSpPr>
        <p:spPr>
          <a:xfrm>
            <a:off x="5079274" y="254697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/>
          <p:cNvSpPr txBox="1"/>
          <p:nvPr/>
        </p:nvSpPr>
        <p:spPr>
          <a:xfrm>
            <a:off x="4941161" y="264698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4803049" y="268032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4669698" y="25422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4531586" y="25517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5217386" y="25945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4146697" y="8460328"/>
            <a:ext cx="4316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dditional file 6: Figure S4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3028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6</TotalTime>
  <Words>134</Words>
  <Application>Microsoft Office PowerPoint</Application>
  <PresentationFormat>On-screen Show (4:3)</PresentationFormat>
  <Paragraphs>10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hmiya14</dc:creator>
  <cp:lastModifiedBy>Balindan, Danica Joy</cp:lastModifiedBy>
  <cp:revision>66</cp:revision>
  <cp:lastPrinted>2017-07-03T02:06:04Z</cp:lastPrinted>
  <dcterms:created xsi:type="dcterms:W3CDTF">2015-04-13T07:25:54Z</dcterms:created>
  <dcterms:modified xsi:type="dcterms:W3CDTF">2017-11-13T05:40:55Z</dcterms:modified>
</cp:coreProperties>
</file>